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7A2D42-1445-4FD9-91E3-3409DAFE7D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F5E305-39DC-45BA-9787-AFA37D0F83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37FCE-F185-4275-97FC-9D0C122525F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1D6F30-7B7B-4255-8E03-08F8E0658C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BA7BDA-FDFF-4E4F-AB04-62EBC0B65B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89880-4936-4FE9-8AAF-46EE2614F2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1816E-20E2-45E6-A82D-6AF98E0E8D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B9C7C-A878-401E-8469-B351816F8C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A274D-AF7E-4980-8B2B-8F9D10AEFE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2A15B-0D2A-4140-BA71-28508C4A40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7517B-F29E-4AB5-B3EB-D19322401E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2A7E1B-56A5-45E2-8795-3F364896DB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971AB6-AEB9-469F-9F8E-890B8D2EC4EB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正方形/長方形 2"/>
          <p:cNvSpPr/>
          <p:nvPr/>
        </p:nvSpPr>
        <p:spPr>
          <a:xfrm>
            <a:off x="304920" y="2781360"/>
            <a:ext cx="839448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Supplemental Figure S3: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F. vesc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 genome positions corresponding to the FANhybrid_r1.2 sequences, as identified by BLAT search. The FANhybrid_r1.2 sequences are aligned on the X axis in the order corresponding to the positions of homologous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F. vesc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 sequences. The Y axis shows the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F. vesc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 genome position corresponding to the FANhybrid_r1.2 sequences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187200" y="392040"/>
            <a:ext cx="8828280" cy="577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3" descr=""/>
          <p:cNvPicPr/>
          <p:nvPr/>
        </p:nvPicPr>
        <p:blipFill>
          <a:blip r:embed="rId1"/>
          <a:stretch/>
        </p:blipFill>
        <p:spPr>
          <a:xfrm>
            <a:off x="187200" y="392040"/>
            <a:ext cx="8828280" cy="577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2" descr=""/>
          <p:cNvPicPr/>
          <p:nvPr/>
        </p:nvPicPr>
        <p:blipFill>
          <a:blip r:embed="rId1"/>
          <a:stretch/>
        </p:blipFill>
        <p:spPr>
          <a:xfrm>
            <a:off x="187200" y="392040"/>
            <a:ext cx="8828280" cy="577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"/>
          <p:cNvPicPr/>
          <p:nvPr/>
        </p:nvPicPr>
        <p:blipFill>
          <a:blip r:embed="rId1"/>
          <a:stretch/>
        </p:blipFill>
        <p:spPr>
          <a:xfrm>
            <a:off x="187200" y="392040"/>
            <a:ext cx="8828280" cy="577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"/>
          <p:cNvPicPr/>
          <p:nvPr/>
        </p:nvPicPr>
        <p:blipFill>
          <a:blip r:embed="rId1"/>
          <a:stretch/>
        </p:blipFill>
        <p:spPr>
          <a:xfrm>
            <a:off x="187200" y="392040"/>
            <a:ext cx="8828280" cy="577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2" descr=""/>
          <p:cNvPicPr/>
          <p:nvPr/>
        </p:nvPicPr>
        <p:blipFill>
          <a:blip r:embed="rId1"/>
          <a:stretch/>
        </p:blipFill>
        <p:spPr>
          <a:xfrm>
            <a:off x="187200" y="392040"/>
            <a:ext cx="8828280" cy="577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187200" y="392040"/>
            <a:ext cx="8828280" cy="577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22T10:05:53Z</dcterms:created>
  <dc:creator>Sachiko Isobe</dc:creator>
  <dc:description/>
  <dc:language>en-US</dc:language>
  <cp:lastModifiedBy>Sachiko Isobe</cp:lastModifiedBy>
  <dcterms:modified xsi:type="dcterms:W3CDTF">2013-09-06T00:49:15Z</dcterms:modified>
  <cp:revision>10</cp:revision>
  <dc:subject/>
  <dc:title>PowerPoint プレゼンテーション</dc:title>
</cp:coreProperties>
</file>